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20" r:id="rId1"/>
  </p:sldMasterIdLst>
  <p:notesMasterIdLst>
    <p:notesMasterId r:id="rId3"/>
  </p:notesMasterIdLst>
  <p:sldIdLst>
    <p:sldId id="262" r:id="rId2"/>
  </p:sldIdLst>
  <p:sldSz cx="6858000" cy="80454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0"/>
    <p:restoredTop sz="94709"/>
  </p:normalViewPr>
  <p:slideViewPr>
    <p:cSldViewPr snapToGrid="0">
      <p:cViewPr varScale="1">
        <p:scale>
          <a:sx n="91" d="100"/>
          <a:sy n="91" d="100"/>
        </p:scale>
        <p:origin x="2888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63D819A-B433-8742-9508-51A9D930A4EA}" type="datetimeFigureOut">
              <a:rPr lang="en-US" smtClean="0"/>
              <a:t>5/21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12963" y="1143000"/>
            <a:ext cx="26320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6B20C74-D844-5C41-8B49-4509F4AA54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59163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12963" y="1143000"/>
            <a:ext cx="26320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ry Figure 3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6B20C74-D844-5C41-8B49-4509F4AA541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50798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316698"/>
            <a:ext cx="5829300" cy="2801009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225724"/>
            <a:ext cx="5143500" cy="1942454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CDE61-DCF7-1A44-B4FD-910FA8B33F42}" type="datetimeFigureOut">
              <a:rPr lang="en-US" smtClean="0"/>
              <a:t>5/2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0A06E-C291-F249-8F0F-BBC27C1E1D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85938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CDE61-DCF7-1A44-B4FD-910FA8B33F42}" type="datetimeFigureOut">
              <a:rPr lang="en-US" smtClean="0"/>
              <a:t>5/2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0A06E-C291-F249-8F0F-BBC27C1E1D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30860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28346"/>
            <a:ext cx="1478756" cy="681814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28346"/>
            <a:ext cx="4350544" cy="681814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CDE61-DCF7-1A44-B4FD-910FA8B33F42}" type="datetimeFigureOut">
              <a:rPr lang="en-US" smtClean="0"/>
              <a:t>5/2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0A06E-C291-F249-8F0F-BBC27C1E1D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03267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CDE61-DCF7-1A44-B4FD-910FA8B33F42}" type="datetimeFigureOut">
              <a:rPr lang="en-US" smtClean="0"/>
              <a:t>5/2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0A06E-C291-F249-8F0F-BBC27C1E1D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11638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005778"/>
            <a:ext cx="5915025" cy="3346683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5384122"/>
            <a:ext cx="5915025" cy="1759942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CDE61-DCF7-1A44-B4FD-910FA8B33F42}" type="datetimeFigureOut">
              <a:rPr lang="en-US" smtClean="0"/>
              <a:t>5/2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0A06E-C291-F249-8F0F-BBC27C1E1D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5053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141729"/>
            <a:ext cx="2914650" cy="510476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141729"/>
            <a:ext cx="2914650" cy="510476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CDE61-DCF7-1A44-B4FD-910FA8B33F42}" type="datetimeFigureOut">
              <a:rPr lang="en-US" smtClean="0"/>
              <a:t>5/21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0A06E-C291-F249-8F0F-BBC27C1E1D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72835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28347"/>
            <a:ext cx="5915025" cy="155508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1972253"/>
            <a:ext cx="2901255" cy="96657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2938824"/>
            <a:ext cx="2901255" cy="432256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1972253"/>
            <a:ext cx="2915543" cy="96657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2938824"/>
            <a:ext cx="2915543" cy="432256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CDE61-DCF7-1A44-B4FD-910FA8B33F42}" type="datetimeFigureOut">
              <a:rPr lang="en-US" smtClean="0"/>
              <a:t>5/21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0A06E-C291-F249-8F0F-BBC27C1E1D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03332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CDE61-DCF7-1A44-B4FD-910FA8B33F42}" type="datetimeFigureOut">
              <a:rPr lang="en-US" smtClean="0"/>
              <a:t>5/21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0A06E-C291-F249-8F0F-BBC27C1E1D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54304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CDE61-DCF7-1A44-B4FD-910FA8B33F42}" type="datetimeFigureOut">
              <a:rPr lang="en-US" smtClean="0"/>
              <a:t>5/21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0A06E-C291-F249-8F0F-BBC27C1E1D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72820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36363"/>
            <a:ext cx="2211884" cy="1877272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158398"/>
            <a:ext cx="3471863" cy="5717484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413635"/>
            <a:ext cx="2211884" cy="447155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CDE61-DCF7-1A44-B4FD-910FA8B33F42}" type="datetimeFigureOut">
              <a:rPr lang="en-US" smtClean="0"/>
              <a:t>5/21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0A06E-C291-F249-8F0F-BBC27C1E1D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33162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36363"/>
            <a:ext cx="2211884" cy="1877272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158398"/>
            <a:ext cx="3471863" cy="5717484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413635"/>
            <a:ext cx="2211884" cy="447155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CDE61-DCF7-1A44-B4FD-910FA8B33F42}" type="datetimeFigureOut">
              <a:rPr lang="en-US" smtClean="0"/>
              <a:t>5/21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0A06E-C291-F249-8F0F-BBC27C1E1D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38606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28347"/>
            <a:ext cx="5915025" cy="155508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141729"/>
            <a:ext cx="5915025" cy="510476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7456942"/>
            <a:ext cx="1543050" cy="42834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7CDE61-DCF7-1A44-B4FD-910FA8B33F42}" type="datetimeFigureOut">
              <a:rPr lang="en-US" smtClean="0"/>
              <a:t>5/2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7456942"/>
            <a:ext cx="2314575" cy="42834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7456942"/>
            <a:ext cx="1543050" cy="42834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40A06E-C291-F249-8F0F-BBC27C1E1D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51308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>
            <a:extLst>
              <a:ext uri="{FF2B5EF4-FFF2-40B4-BE49-F238E27FC236}">
                <a16:creationId xmlns:a16="http://schemas.microsoft.com/office/drawing/2014/main" id="{3470621D-AA9B-4072-192D-2E2EC516C69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80386" y="549041"/>
            <a:ext cx="2120900" cy="323850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2E1A0F65-4769-4353-06B4-975CDB18E7A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43824" y="543442"/>
            <a:ext cx="2120900" cy="323850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D53A1A11-7833-82E0-F992-626B5E9313A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-13252" y="550095"/>
            <a:ext cx="2120900" cy="32385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79DE37C0-05AC-4E4A-64FE-BD635C46EAE7}"/>
              </a:ext>
            </a:extLst>
          </p:cNvPr>
          <p:cNvSpPr txBox="1"/>
          <p:nvPr/>
        </p:nvSpPr>
        <p:spPr>
          <a:xfrm>
            <a:off x="0" y="41628"/>
            <a:ext cx="3291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C4F3196-9EB8-9E55-C58D-07CC669A3BDE}"/>
              </a:ext>
            </a:extLst>
          </p:cNvPr>
          <p:cNvSpPr txBox="1"/>
          <p:nvPr/>
        </p:nvSpPr>
        <p:spPr>
          <a:xfrm>
            <a:off x="490728" y="3708655"/>
            <a:ext cx="15026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non-NPSLE        NPSL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3D79716-E216-BC93-E597-767DF12C82FA}"/>
              </a:ext>
            </a:extLst>
          </p:cNvPr>
          <p:cNvSpPr txBox="1"/>
          <p:nvPr/>
        </p:nvSpPr>
        <p:spPr>
          <a:xfrm>
            <a:off x="2877312" y="3708655"/>
            <a:ext cx="15026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non-NPSLE        NPSLE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648C729-CA95-DF44-1AD6-A87016E7BE9E}"/>
              </a:ext>
            </a:extLst>
          </p:cNvPr>
          <p:cNvSpPr txBox="1"/>
          <p:nvPr/>
        </p:nvSpPr>
        <p:spPr>
          <a:xfrm>
            <a:off x="5179348" y="3708655"/>
            <a:ext cx="15026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non-NPSLE        NPSLE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C944E70-72AB-E373-AD0C-0C5E86BCD474}"/>
              </a:ext>
            </a:extLst>
          </p:cNvPr>
          <p:cNvSpPr txBox="1"/>
          <p:nvPr/>
        </p:nvSpPr>
        <p:spPr>
          <a:xfrm>
            <a:off x="0" y="3892359"/>
            <a:ext cx="3291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B53EE4C-64E9-5F18-CDF6-39E45B558C29}"/>
              </a:ext>
            </a:extLst>
          </p:cNvPr>
          <p:cNvSpPr txBox="1"/>
          <p:nvPr/>
        </p:nvSpPr>
        <p:spPr>
          <a:xfrm>
            <a:off x="490728" y="180132"/>
            <a:ext cx="150266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Ocular</a:t>
            </a:r>
          </a:p>
          <a:p>
            <a:pPr algn="ctr"/>
            <a:r>
              <a:rPr lang="en-US" sz="1200" dirty="0"/>
              <a:t>Category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AE4BFDD-F36F-AB44-577F-10D80C8A3015}"/>
              </a:ext>
            </a:extLst>
          </p:cNvPr>
          <p:cNvSpPr txBox="1"/>
          <p:nvPr/>
        </p:nvSpPr>
        <p:spPr>
          <a:xfrm>
            <a:off x="2864060" y="180132"/>
            <a:ext cx="150266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Pulmonary</a:t>
            </a:r>
          </a:p>
          <a:p>
            <a:pPr algn="ctr"/>
            <a:r>
              <a:rPr lang="en-US" sz="1200" dirty="0"/>
              <a:t>Category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CD37289-A5B7-577F-1E35-92DD9BA80FBB}"/>
              </a:ext>
            </a:extLst>
          </p:cNvPr>
          <p:cNvSpPr txBox="1"/>
          <p:nvPr/>
        </p:nvSpPr>
        <p:spPr>
          <a:xfrm>
            <a:off x="5219104" y="180132"/>
            <a:ext cx="150266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Gastrointestinal</a:t>
            </a:r>
          </a:p>
          <a:p>
            <a:pPr algn="ctr"/>
            <a:r>
              <a:rPr lang="en-US" sz="1200" dirty="0"/>
              <a:t>Category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EF5ED558-B99F-6988-1381-877A67CAD3A2}"/>
              </a:ext>
            </a:extLst>
          </p:cNvPr>
          <p:cNvSpPr/>
          <p:nvPr/>
        </p:nvSpPr>
        <p:spPr>
          <a:xfrm>
            <a:off x="3454751" y="6477520"/>
            <a:ext cx="1574380" cy="11277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29AEB048-6925-48ED-0571-EDE75D44835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0" y="4181863"/>
            <a:ext cx="6858000" cy="2391798"/>
          </a:xfrm>
          <a:prstGeom prst="rect">
            <a:avLst/>
          </a:prstGeom>
        </p:spPr>
      </p:pic>
      <p:sp>
        <p:nvSpPr>
          <p:cNvPr id="14" name="Rectangle 13">
            <a:extLst>
              <a:ext uri="{FF2B5EF4-FFF2-40B4-BE49-F238E27FC236}">
                <a16:creationId xmlns:a16="http://schemas.microsoft.com/office/drawing/2014/main" id="{EDD677CF-32EB-82ED-2EDA-B5BBD5077E55}"/>
              </a:ext>
            </a:extLst>
          </p:cNvPr>
          <p:cNvSpPr/>
          <p:nvPr/>
        </p:nvSpPr>
        <p:spPr>
          <a:xfrm>
            <a:off x="1242060" y="4362324"/>
            <a:ext cx="279400" cy="152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B9561685-ACA0-F40C-2038-0FA05710B1D2}"/>
              </a:ext>
            </a:extLst>
          </p:cNvPr>
          <p:cNvSpPr/>
          <p:nvPr/>
        </p:nvSpPr>
        <p:spPr>
          <a:xfrm>
            <a:off x="1506780" y="5301562"/>
            <a:ext cx="279400" cy="152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E822BE49-66D6-E9E2-0DEE-3C28154C6CB3}"/>
              </a:ext>
            </a:extLst>
          </p:cNvPr>
          <p:cNvSpPr/>
          <p:nvPr/>
        </p:nvSpPr>
        <p:spPr>
          <a:xfrm>
            <a:off x="1002870" y="5857794"/>
            <a:ext cx="279400" cy="152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09E07D6-95B1-4DCC-F92A-845C73406227}"/>
              </a:ext>
            </a:extLst>
          </p:cNvPr>
          <p:cNvSpPr txBox="1"/>
          <p:nvPr/>
        </p:nvSpPr>
        <p:spPr>
          <a:xfrm>
            <a:off x="1134959" y="4382402"/>
            <a:ext cx="6434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(Yes/no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39F1A74-EB3D-17FC-7113-A53F53657AB4}"/>
              </a:ext>
            </a:extLst>
          </p:cNvPr>
          <p:cNvSpPr txBox="1"/>
          <p:nvPr/>
        </p:nvSpPr>
        <p:spPr>
          <a:xfrm>
            <a:off x="1408064" y="5317867"/>
            <a:ext cx="6434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(Yes/no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D79397D-3CCC-5762-E512-158041B0FD00}"/>
              </a:ext>
            </a:extLst>
          </p:cNvPr>
          <p:cNvSpPr txBox="1"/>
          <p:nvPr/>
        </p:nvSpPr>
        <p:spPr>
          <a:xfrm>
            <a:off x="904826" y="5854979"/>
            <a:ext cx="6434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(Yes/no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9795B8B-98F7-43E9-1326-41BA68F6420D}"/>
              </a:ext>
            </a:extLst>
          </p:cNvPr>
          <p:cNvSpPr txBox="1"/>
          <p:nvPr/>
        </p:nvSpPr>
        <p:spPr>
          <a:xfrm>
            <a:off x="-13252" y="6528005"/>
            <a:ext cx="3291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</a:t>
            </a:r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id="{08D319E6-068E-2372-C1C5-5AE950954D7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-13252" y="6835334"/>
            <a:ext cx="6858000" cy="8243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120717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Theme">
  <a:themeElements>
    <a:clrScheme name="Office 2013 - 2022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023</TotalTime>
  <Words>34</Words>
  <Application>Microsoft Macintosh PowerPoint</Application>
  <PresentationFormat>Custom</PresentationFormat>
  <Paragraphs>1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2013 - 2022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ionysis Nikolopoulos</dc:creator>
  <cp:lastModifiedBy>Dionysis Nikolopoulos</cp:lastModifiedBy>
  <cp:revision>6</cp:revision>
  <dcterms:created xsi:type="dcterms:W3CDTF">2024-02-20T14:23:55Z</dcterms:created>
  <dcterms:modified xsi:type="dcterms:W3CDTF">2024-05-21T11:21:26Z</dcterms:modified>
</cp:coreProperties>
</file>